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36410-3ACF-49AA-9D59-B09ACA52BA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0A5A8-EEA4-48D1-8307-9537EEAD48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B4FB4-63D2-4279-A30F-3B2B019093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7DAA4-5962-46BC-A58F-C70A86814E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9128B-01A0-4D54-9DA2-6F98BA843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CA90A-179F-40E6-8B34-A04E7938A7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2651C-3C64-4ED2-87CD-00217D4B46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40A4D-2F8D-47BC-8E4A-4FDAFC657E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39324-CDB6-4C38-9CE3-1AF2E5BDE5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34F3C-BA3B-4D22-B3C9-2F7A45E6CD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A81B98-3E97-4EBE-B87C-0CC849F9A6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DB712-AACF-4EB4-A366-5497516769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D542B12-5C38-4089-B408-1EDA2CD7B2D7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2B1710F-23FA-4107-9ADF-6DB5D361E6E7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co 4" descr=""/>
          <p:cNvPicPr/>
          <p:nvPr/>
        </p:nvPicPr>
        <p:blipFill>
          <a:blip r:embed="rId1"/>
          <a:stretch/>
        </p:blipFill>
        <p:spPr>
          <a:xfrm>
            <a:off x="665280" y="1670040"/>
            <a:ext cx="6064200" cy="2603520"/>
          </a:xfrm>
          <a:prstGeom prst="rect">
            <a:avLst/>
          </a:prstGeom>
          <a:ln w="0">
            <a:noFill/>
          </a:ln>
        </p:spPr>
      </p:pic>
      <p:grpSp>
        <p:nvGrpSpPr>
          <p:cNvPr id="42" name="Gruppo 10"/>
          <p:cNvGrpSpPr/>
          <p:nvPr/>
        </p:nvGrpSpPr>
        <p:grpSpPr>
          <a:xfrm>
            <a:off x="5961240" y="1892160"/>
            <a:ext cx="1528560" cy="482040"/>
            <a:chOff x="5961240" y="1892160"/>
            <a:chExt cx="1528560" cy="482040"/>
          </a:xfrm>
        </p:grpSpPr>
        <p:sp>
          <p:nvSpPr>
            <p:cNvPr id="43" name="Rettangolo 11"/>
            <p:cNvSpPr/>
            <p:nvPr/>
          </p:nvSpPr>
          <p:spPr>
            <a:xfrm>
              <a:off x="5961240" y="1963440"/>
              <a:ext cx="107640" cy="1094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ttangolo 12"/>
            <p:cNvSpPr/>
            <p:nvPr/>
          </p:nvSpPr>
          <p:spPr>
            <a:xfrm>
              <a:off x="5961240" y="2189160"/>
              <a:ext cx="107640" cy="10800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CasellaDiTesto 13"/>
            <p:cNvSpPr/>
            <p:nvPr/>
          </p:nvSpPr>
          <p:spPr>
            <a:xfrm>
              <a:off x="6072120" y="1892160"/>
              <a:ext cx="1238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pregulated TC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14"/>
            <p:cNvSpPr/>
            <p:nvPr/>
          </p:nvSpPr>
          <p:spPr>
            <a:xfrm>
              <a:off x="6073200" y="2112840"/>
              <a:ext cx="1416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wnregulated TC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" name="CasellaDiTesto 16"/>
          <p:cNvSpPr/>
          <p:nvPr/>
        </p:nvSpPr>
        <p:spPr>
          <a:xfrm>
            <a:off x="668160" y="4189320"/>
            <a:ext cx="71042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3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Functional categorization of Tentative Consensus (TCs) showing differential hybridization signals in IL10-1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v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M82. Categorization was performed according to GO Cellular Component (CC) vocabulary as retrieved through Blast2GO Gene Ontology mapping. Differentially expressed TCs were categorized as split into up-regulated and down-regulated TCs and  calculated as percentage of the total number of classifications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9T10:52:17Z</dcterms:created>
  <dc:creator>amalia  barone</dc:creator>
  <dc:description/>
  <dc:language>en-US</dc:language>
  <cp:lastModifiedBy>Amalia</cp:lastModifiedBy>
  <dcterms:modified xsi:type="dcterms:W3CDTF">2011-12-29T14:46:04Z</dcterms:modified>
  <cp:revision>6</cp:revision>
  <dc:subject/>
  <dc:title>Diapositiva 1</dc:title>
</cp:coreProperties>
</file>